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58" r:id="rId3"/>
    <p:sldId id="259" r:id="rId4"/>
    <p:sldId id="260" r:id="rId5"/>
    <p:sldId id="261" r:id="rId6"/>
    <p:sldId id="262" r:id="rId7"/>
    <p:sldId id="263" r:id="rId8"/>
    <p:sldId id="264" r:id="rId9"/>
    <p:sldId id="265" r:id="rId10"/>
    <p:sldId id="266" r:id="rId11"/>
    <p:sldId id="267" r:id="rId12"/>
    <p:sldId id="268" r:id="rId13"/>
    <p:sldId id="269" r:id="rId14"/>
    <p:sldId id="270" r:id="rId15"/>
    <p:sldId id="271" r:id="rId16"/>
    <p:sldId id="272" r:id="rId17"/>
    <p:sldId id="273" r:id="rId18"/>
  </p:sldIdLst>
  <p:sldSz cx="9144000" cy="6858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BCD1491-1287-47B2-AC73-1A11CDE7C330}" v="3" dt="2019-04-28T08:05:53.37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>
        <p:scale>
          <a:sx n="75" d="100"/>
          <a:sy n="75" d="100"/>
        </p:scale>
        <p:origin x="-1800" y="-1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presProps" Target="presProps.xml"/><Relationship Id="rId21" Type="http://schemas.openxmlformats.org/officeDocument/2006/relationships/viewProps" Target="viewProps.xml"/><Relationship Id="rId22" Type="http://schemas.openxmlformats.org/officeDocument/2006/relationships/theme" Target="theme/theme1.xml"/><Relationship Id="rId23" Type="http://schemas.openxmlformats.org/officeDocument/2006/relationships/tableStyles" Target="tableStyles.xml"/><Relationship Id="rId24" Type="http://schemas.microsoft.com/office/2015/10/relationships/revisionInfo" Target="revisionInfo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printerSettings" Target="printerSettings/printerSettings1.bin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10DF29-2112-714A-A0A5-67BB292CADD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39226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04E0647-81A8-A94E-B0EE-BB70AB5BF29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025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4FA6D73-01AC-1043-A9D3-7F3AEF13667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0643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5F7D1D8-2FA3-A745-8B1E-030D56627599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3310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1CD6FC-9CB1-3D49-9C36-ED3D3AA916D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25004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FDA56DE-394F-0243-BD78-4921596FCD5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06653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0E3EB3-085B-D34F-B1DE-4883D8DBBEE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261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48D32DF-9045-BF49-9973-3AE45A38D104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3089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5A40B34-CC26-EF4C-ACF1-D2B7F08E6FF3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12159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B015C86-E6CA-E642-AA2A-83208264CC2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47342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de-DE" noProof="0"/>
              <a:t>Bild auf Platzhalter ziehen oder durch Klicken auf Symbol hinzufügen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C7C878D-7A7A-8046-9E77-375E55D597E5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03267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/>
              <a:t>Textmasterformate durch Klicken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715146D4-3F18-134F-971C-B72D3092572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charset="0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charset="0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charset="0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charset="0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0.jpe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1.jpe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2.jpe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jpe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jpe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jpe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6.jpe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e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4.jpe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jpe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8.jpe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569660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 dirty="0" err="1">
                <a:latin typeface="Arial"/>
                <a:ea typeface="ＭＳ Ｐゴシック"/>
              </a:rPr>
              <a:t>Figure</a:t>
            </a:r>
            <a:r>
              <a:rPr lang="de-DE" sz="1200" b="1" dirty="0">
                <a:latin typeface="Arial"/>
                <a:ea typeface="ＭＳ Ｐゴシック"/>
              </a:rPr>
              <a:t> S1: 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In </a:t>
            </a:r>
            <a:r>
              <a:rPr lang="de-DE" sz="1200" dirty="0" err="1">
                <a:latin typeface="Arial"/>
                <a:ea typeface="ＭＳ Ｐゴシック"/>
                <a:cs typeface="Arial"/>
              </a:rPr>
              <a:t>center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 1, 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462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isolates from 15 patients were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  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assigned to 50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-types and grouped into 6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-CCs (with 23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types). For 4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-types, no founder CC was determined, while 19 were singletons and 4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-types excluded by the </a:t>
            </a:r>
            <a:r>
              <a:rPr lang="en-US" sz="1200" dirty="0" err="1">
                <a:latin typeface="Arial"/>
                <a:ea typeface="ＭＳ Ｐゴシック"/>
                <a:cs typeface="Arial"/>
              </a:rPr>
              <a:t>eBURP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algorithm. The size of the circles represents the frequency of </a:t>
            </a:r>
            <a:r>
              <a:rPr lang="en-US" sz="1200" i="1" dirty="0">
                <a:latin typeface="Arial"/>
                <a:ea typeface="ＭＳ Ｐゴシック"/>
                <a:cs typeface="Arial"/>
              </a:rPr>
              <a:t>spa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-types, the blue color marks the main founders, yellow the sub founders and black the descendants, respectively. </a:t>
            </a:r>
            <a:br>
              <a:rPr lang="en-US" sz="1200" dirty="0">
                <a:latin typeface="Arial"/>
                <a:ea typeface="ＭＳ Ｐゴシック"/>
                <a:cs typeface="Arial"/>
              </a:rPr>
            </a:br>
            <a:endParaRPr lang="en-US" sz="1200" dirty="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06804" cy="138499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 dirty="0">
                <a:latin typeface="Arial"/>
                <a:ea typeface="ＭＳ Ｐゴシック"/>
              </a:rPr>
              <a:t>Singletons: 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t005, t045, t078, t091, </a:t>
            </a:r>
            <a:endParaRPr lang="de-DE" sz="1200" dirty="0">
              <a:cs typeface="Arial"/>
            </a:endParaRPr>
          </a:p>
          <a:p>
            <a:r>
              <a:rPr lang="de-DE" sz="1200" dirty="0">
                <a:latin typeface="Arial"/>
                <a:ea typeface="ＭＳ Ｐゴシック"/>
                <a:cs typeface="Arial"/>
              </a:rPr>
              <a:t>t094, t159, t164, t209, t493, t550, </a:t>
            </a:r>
            <a:endParaRPr lang="de-DE" sz="1200" dirty="0">
              <a:cs typeface="Arial"/>
            </a:endParaRPr>
          </a:p>
          <a:p>
            <a:r>
              <a:rPr lang="de-DE" sz="1200" dirty="0">
                <a:latin typeface="Arial"/>
                <a:ea typeface="ＭＳ Ｐゴシック"/>
                <a:cs typeface="Arial"/>
              </a:rPr>
              <a:t>t884, t1406, t1577, t2080, t2133, </a:t>
            </a:r>
            <a:endParaRPr lang="de-DE" sz="1200" dirty="0">
              <a:cs typeface="Arial"/>
            </a:endParaRPr>
          </a:p>
          <a:p>
            <a:r>
              <a:rPr lang="de-DE" sz="1200" dirty="0">
                <a:latin typeface="Arial"/>
                <a:ea typeface="ＭＳ Ｐゴシック"/>
                <a:cs typeface="Arial"/>
              </a:rPr>
              <a:t>t3331, t4870, t5761, t6172</a:t>
            </a:r>
            <a:endParaRPr lang="de-DE" sz="1200" dirty="0">
              <a:cs typeface="Arial"/>
            </a:endParaRPr>
          </a:p>
          <a:p>
            <a:endParaRPr lang="de-DE" sz="1200" b="1" dirty="0">
              <a:latin typeface="Arial"/>
              <a:ea typeface="ＭＳ Ｐゴシック"/>
              <a:cs typeface="Arial"/>
            </a:endParaRPr>
          </a:p>
          <a:p>
            <a:r>
              <a:rPr lang="de-DE" sz="1200" b="1" dirty="0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 i="1" dirty="0" err="1">
                <a:latin typeface="Arial"/>
                <a:ea typeface="ＭＳ Ｐゴシック"/>
                <a:cs typeface="Arial"/>
              </a:rPr>
              <a:t>spa</a:t>
            </a:r>
            <a:r>
              <a:rPr lang="de-DE" sz="1200" b="1" dirty="0" err="1">
                <a:latin typeface="Arial"/>
                <a:ea typeface="ＭＳ Ｐゴシック"/>
                <a:cs typeface="Arial"/>
              </a:rPr>
              <a:t>-types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: </a:t>
            </a:r>
          </a:p>
          <a:p>
            <a:r>
              <a:rPr lang="de-DE" sz="1200" dirty="0">
                <a:latin typeface="Arial"/>
                <a:cs typeface="Arial"/>
              </a:rPr>
              <a:t>t559, t1050, t1544, t3745</a:t>
            </a:r>
            <a:endParaRPr lang="de-DE" dirty="0">
              <a:latin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A0B478D5-9A0E-4339-B4E0-DDA72BCB0DC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7895" r="-134" b="7895"/>
          <a:stretch/>
        </p:blipFill>
        <p:spPr>
          <a:xfrm>
            <a:off x="1573029" y="1084262"/>
            <a:ext cx="5926515" cy="335874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7404084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0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0, 94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7 patients were assigned to 16 spa-types and grouped into 2 CCs (with 6 spa-types). For 2 spa-types no founder CC was determined, while 7 spa-types were singletons and 1 spa-type excluded by the eBURP algorithm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222083" cy="156966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15, t045, t056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084, t091, t449, t2802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362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>
            <a:extLst>
              <a:ext uri="{FF2B5EF4-FFF2-40B4-BE49-F238E27FC236}">
                <a16:creationId xmlns:a16="http://schemas.microsoft.com/office/drawing/2014/main" xmlns="" id="{DF6181D0-290A-4133-B4E8-101D48F1F4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9123" r="-134" b="42055"/>
          <a:stretch/>
        </p:blipFill>
        <p:spPr>
          <a:xfrm>
            <a:off x="1509529" y="2108200"/>
            <a:ext cx="5926515" cy="17570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874219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200329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1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1, 239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13 patients were assigned to 34 spa-types and grouped into 6 CCs (with 21 spa-types). For 2 spa-types, no founder CC was determined, while 11 spa-types were singletons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363147" cy="193899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5, t091, t156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571, t728, t1707, t2080, t4228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4325, t5758, t6195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endParaRPr lang="de-DE" sz="1200"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-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FFC5D35C-BF21-4520-81CE-D0D9EECF4A3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3333" r="-134"/>
          <a:stretch/>
        </p:blipFill>
        <p:spPr>
          <a:xfrm>
            <a:off x="1493654" y="917575"/>
            <a:ext cx="5926515" cy="39225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34542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2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2, 170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10 patients were assigned to 35 spa-types and grouped into 3 CCs (with 13 spa-types). For 10 spa-types, no founder CC was determined, while 11 spa-types were singletons and 1 spa-type was excluded by the eBURP algorithm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351734" cy="193899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8, t153, t190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688, t701, t1211, t1652, t4325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6191, t6194, t10605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 </a:t>
            </a:r>
            <a:r>
              <a:rPr lang="de-DE" sz="1200">
                <a:latin typeface="Arial"/>
                <a:ea typeface="ＭＳ Ｐゴシック"/>
                <a:cs typeface="Arial"/>
              </a:rPr>
              <a:t>t390</a:t>
            </a:r>
            <a:endParaRPr lang="de-DE" sz="1200">
              <a:cs typeface="Arial"/>
            </a:endParaRP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 descr="Ein Bild, das Screenshot enthält.&#10;&#10;Mit hoher Zuverlässigkeit generierte Beschreibung">
            <a:extLst>
              <a:ext uri="{FF2B5EF4-FFF2-40B4-BE49-F238E27FC236}">
                <a16:creationId xmlns:a16="http://schemas.microsoft.com/office/drawing/2014/main" xmlns="" id="{4FDC950D-8C39-4640-87D7-24EC416CE27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4035" r="-134" b="21404"/>
          <a:stretch/>
        </p:blipFill>
        <p:spPr>
          <a:xfrm>
            <a:off x="1580967" y="1314450"/>
            <a:ext cx="5926515" cy="29220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00558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200329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3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3, 121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6 patients were assigned to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17 spa-types and grouped into 2 CCs (with 11 spa-types). For 2 spa-types, no founder CC was determined, while 4 spa-types were singletons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1891865" cy="193899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09, t2845, t6194, t6376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-</a:t>
            </a: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95F00006-AE97-43BE-BF32-ABF01CDE340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6667" r="-134" b="26441"/>
          <a:stretch/>
        </p:blipFill>
        <p:spPr>
          <a:xfrm>
            <a:off x="1493654" y="1600200"/>
            <a:ext cx="5926515" cy="25749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657415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4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4, 407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25 patients were assigned to 53 spa-types and grouped into 5 CCs (with 18 spa-types). For 16 spa-types, no founder CC was determined, while 14 spa-types were singletons and 5 spa-types excluded by the eBURP algorithm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06804" cy="2123658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65, t099, t127, t186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209, t230, t1416, t2919, t4451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6192, t6193, t6195, t6375, t9887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6, t362, t693, t2383, t5687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9" name="Grafik 9">
            <a:extLst>
              <a:ext uri="{FF2B5EF4-FFF2-40B4-BE49-F238E27FC236}">
                <a16:creationId xmlns:a16="http://schemas.microsoft.com/office/drawing/2014/main" xmlns="" id="{565CC24B-1B78-4EFC-B782-FD60161297D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4912" r="-134"/>
          <a:stretch/>
        </p:blipFill>
        <p:spPr>
          <a:xfrm>
            <a:off x="1493654" y="703263"/>
            <a:ext cx="5926515" cy="385104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205100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200329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5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5, 66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3 patients were assigned to 12 spa-types. For 4 spa-types no founder CC was determined, while 8 spa-types were singletons. The size of the circles represents the frequency of spa-types, the blue color marks the main founders, yellow the sub founders and black the descendants, respectively. 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endParaRPr lang="de-DE" sz="1200" dirty="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222083" cy="2123658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5, t008, t012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015, t065, t084, t091, t4325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-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6">
            <a:extLst>
              <a:ext uri="{FF2B5EF4-FFF2-40B4-BE49-F238E27FC236}">
                <a16:creationId xmlns:a16="http://schemas.microsoft.com/office/drawing/2014/main" xmlns="" id="{D1AA7253-A941-4D12-AE06-C405B474484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4912" r="-134" b="59453"/>
          <a:stretch/>
        </p:blipFill>
        <p:spPr>
          <a:xfrm>
            <a:off x="1350779" y="2608263"/>
            <a:ext cx="5926515" cy="11602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759226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6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6, 202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7 patients were assigned to 32 spa-types and grouped into 3 CCs (with 12 spa-types). For 9 spa-types, no founder CC was determined, while 9 spa-types were singletons and 1 spa-type excluded by the eBURP algorithm. The size of the circles represents the frequency of spa-types, the blue color marks the main founders, yellow the sub founders and black the descendants, respectively. </a:t>
            </a:r>
            <a:endParaRPr lang="de-DE" sz="1200" b="1" dirty="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91763" cy="193899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2, t065, t091, t1652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1670, t1978, t2553, t9888, t12681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 </a:t>
            </a:r>
            <a:r>
              <a:rPr lang="de-DE" sz="1200">
                <a:latin typeface="Arial"/>
                <a:ea typeface="ＭＳ Ｐゴシック"/>
                <a:cs typeface="Arial"/>
              </a:rPr>
              <a:t>t362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 descr="Ein Bild, das Screenshot enthält.&#10;&#10;Mit hoher Zuverlässigkeit generierte Beschreibung">
            <a:extLst>
              <a:ext uri="{FF2B5EF4-FFF2-40B4-BE49-F238E27FC236}">
                <a16:creationId xmlns:a16="http://schemas.microsoft.com/office/drawing/2014/main" xmlns="" id="{67077996-3840-494B-94BD-91C07C471B4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7193" r="-134" b="26757"/>
          <a:stretch/>
        </p:blipFill>
        <p:spPr>
          <a:xfrm>
            <a:off x="1414279" y="1758950"/>
            <a:ext cx="5926515" cy="25368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952244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17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17, 447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23 patients were assigned to 48 spa-types and grouped into 6 CCs (with 25 spa-types). For 10 spa-types, no founder CC was determined, while 10 spa-types were singletons and 3 spa-types excluded by the eBURP algorithm. The size of the circles represents the frequency of spa-types, the blue color marks the main founders, yellow the sub founders and black the descendants, respectively. 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 </a:t>
            </a:r>
            <a:endParaRPr lang="de-DE" sz="1200" dirty="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222083" cy="2308324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8, t156, t164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166, t209, t359, t364, t1345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2787, t3258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6, t524, t7065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>
            <a:extLst>
              <a:ext uri="{FF2B5EF4-FFF2-40B4-BE49-F238E27FC236}">
                <a16:creationId xmlns:a16="http://schemas.microsoft.com/office/drawing/2014/main" xmlns="" id="{068FE7C5-C6F7-40CD-ADAD-CB69F428156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3158" r="-134"/>
          <a:stretch/>
        </p:blipFill>
        <p:spPr>
          <a:xfrm>
            <a:off x="1453967" y="679450"/>
            <a:ext cx="5926515" cy="39304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228929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nhaltsplatzhalter 5" descr="Figure S2.jpg"/>
          <p:cNvPicPr>
            <a:picLocks noGrp="1" noChangeAspect="1"/>
          </p:cNvPicPr>
          <p:nvPr>
            <p:ph idx="1"/>
          </p:nvPr>
        </p:nvPicPr>
        <p:blipFill>
          <a:blip r:embed="rId2" cstate="email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41" b="14041"/>
          <a:stretch>
            <a:fillRect/>
          </a:stretch>
        </p:blipFill>
        <p:spPr>
          <a:xfrm>
            <a:off x="559936" y="911516"/>
            <a:ext cx="7028944" cy="3865648"/>
          </a:xfrm>
        </p:spPr>
      </p:pic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2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2, 262 </a:t>
            </a:r>
            <a:r>
              <a:rPr lang="de-DE" sz="1200" i="1">
                <a:latin typeface="Arial"/>
                <a:ea typeface="ＭＳ Ｐゴシック"/>
                <a:cs typeface="Arial"/>
              </a:rPr>
              <a:t>S. aureus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12 patients were assigned to 35 spa-types and grouped into 3 spa-CCs (with 15 spa-types). For 8 spa-types, no founder CC was determined, while 10 spa-types were singletons and 2 spa-types excluded by the eBURP algorithm. The size of the circles represents the frequency of spa-types, the blue color marks the main founders, yellow the sub founders and black the descendants, respectively. </a:t>
            </a:r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06804" cy="830997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 dirty="0">
                <a:latin typeface="Arial"/>
                <a:ea typeface="ＭＳ Ｐゴシック"/>
              </a:rPr>
              <a:t>Singletons: 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t015, t034, t045, t065, </a:t>
            </a:r>
            <a:endParaRPr lang="de-DE" sz="1200" b="1" dirty="0">
              <a:cs typeface="Arial"/>
            </a:endParaRPr>
          </a:p>
          <a:p>
            <a:r>
              <a:rPr lang="de-DE" sz="1200" dirty="0">
                <a:latin typeface="Arial"/>
                <a:ea typeface="ＭＳ Ｐゴシック"/>
                <a:cs typeface="Arial"/>
              </a:rPr>
              <a:t>t185, t209, t645, t950, t5154, t5683</a:t>
            </a:r>
            <a:endParaRPr lang="de-DE" sz="1200" b="1" dirty="0"/>
          </a:p>
          <a:p>
            <a:endParaRPr lang="de-DE" sz="1200" b="1" dirty="0">
              <a:latin typeface="Arial"/>
              <a:ea typeface="ＭＳ Ｐゴシック"/>
              <a:cs typeface="Arial"/>
            </a:endParaRPr>
          </a:p>
          <a:p>
            <a:r>
              <a:rPr lang="de-DE" sz="1200" b="1" dirty="0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 dirty="0" err="1">
                <a:latin typeface="Arial"/>
                <a:ea typeface="ＭＳ Ｐゴシック"/>
                <a:cs typeface="Arial"/>
              </a:rPr>
              <a:t>spa-types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: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>t026, t779</a:t>
            </a:r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814434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3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3, 304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10 patients were assigned to 38 spa-types and grouped into 4 CCs (with 20 spa-types). For 4 spa-types, no founder CC was determined, while 11 spa-types were singletons and 3 spa-types excluded by the eBURP algorithm. The size of the circles represents the frequency of spa-types, the blue color marks the main founders, yellow the sub founders and black the descendants, respectively. </a:t>
            </a:r>
            <a:endParaRPr lang="de-DE" dirty="0"/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492990" cy="1200329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2, t100, t122, t209, t377, t435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539, t712, t746, t2441, t5690</a:t>
            </a:r>
          </a:p>
          <a:p>
            <a:endParaRPr lang="de-DE" sz="1200" b="1" dirty="0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 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6, t1050, t2383</a:t>
            </a: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1DE4088F-82CA-4003-B3AC-7CE4674F6FB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20626" r="89"/>
          <a:stretch/>
        </p:blipFill>
        <p:spPr>
          <a:xfrm>
            <a:off x="1423965" y="866164"/>
            <a:ext cx="5913329" cy="359245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22911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200329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4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4, 258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4 patients were assigned to 13 spa-types and grouped into 1 CC (with 4 spa-types). For 2 spa-types, no founder CC was determined, while 7 spa-types were singletons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1808508" cy="138499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50, t091, t346, t1333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1451, t4989, t7271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-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 descr="Ein Bild, das Screenshot enthält.&#10;&#10;Mit hoher Zuverlässigkeit generierte Beschreibung">
            <a:extLst>
              <a:ext uri="{FF2B5EF4-FFF2-40B4-BE49-F238E27FC236}">
                <a16:creationId xmlns:a16="http://schemas.microsoft.com/office/drawing/2014/main" xmlns="" id="{23DDBF41-6F29-4BE5-B0EA-9718EDF8033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9799" t="17193" r="6711" b="27368"/>
          <a:stretch/>
        </p:blipFill>
        <p:spPr>
          <a:xfrm>
            <a:off x="1898466" y="1782763"/>
            <a:ext cx="4941413" cy="25091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0345842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5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5, 355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22 patients were assigned to 40 spa-types and grouped into 3 CCs (with 3 spa-types). For 12 spa-types, no founder CC was determined, while 12 spa-types were singletons and 3 spa-types excluded by the eBURP algorithm. The size of the circles represents the frequency of spa-types, the blue color marks the main founders, yellow the sub founders and black the descendants, respectively. </a:t>
            </a:r>
            <a:r>
              <a:rPr lang="de-DE" sz="1200" b="1" dirty="0">
                <a:latin typeface="Arial"/>
                <a:ea typeface="ＭＳ Ｐゴシック"/>
              </a:rPr>
              <a:t>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746265" cy="1384995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02, t003, t008, t190, t209, t246, </a:t>
            </a: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488, t647, t2080, t5688, t5759, t9896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6, t129, t3745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E3A8A866-2686-4AF1-BD49-B4403A6B1590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20175" r="-1074" b="-50"/>
          <a:stretch/>
        </p:blipFill>
        <p:spPr>
          <a:xfrm>
            <a:off x="1422217" y="925513"/>
            <a:ext cx="5982126" cy="36150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682789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6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6, 96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4 patients were assigned to 14 spa-types and grouped into 1 CC (with 4 spa-types). For 4 spa-types, no founder CC was determined, while 5 spa-types were singletons and 1 spa-type excluded by the eBURP algorithm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361544" cy="1200329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15, t803, t2065, t5152, t12680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endParaRPr lang="de-DE" sz="1200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103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 descr="Ein Bild, das Screenshot enthält.&#10;&#10;Mit hoher Zuverlässigkeit generierte Beschreibung">
            <a:extLst>
              <a:ext uri="{FF2B5EF4-FFF2-40B4-BE49-F238E27FC236}">
                <a16:creationId xmlns:a16="http://schemas.microsoft.com/office/drawing/2014/main" xmlns="" id="{9920C783-6F91-491E-A00D-E7F946AA203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6316" r="-134" b="22933"/>
          <a:stretch/>
        </p:blipFill>
        <p:spPr>
          <a:xfrm>
            <a:off x="1453967" y="1560512"/>
            <a:ext cx="5926515" cy="2749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263229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7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7, 147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6 patients were assigned to 21 spa-types and no spa-CC was identified. For 6 spa-types, no founder CC was determined, while 12 spa-types were singletons and 3 spa-types excluded by the eBURP algorithm. The size of the circles represents the frequency of spa-types, the blue color marks the main founders, yellow the sub founders and black the descendants, respectively. </a:t>
            </a:r>
            <a:r>
              <a:rPr lang="de-DE" sz="1200" b="1" dirty="0">
                <a:latin typeface="Arial"/>
                <a:ea typeface="ＭＳ Ｐゴシック"/>
              </a:rPr>
              <a:t>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62908" cy="156966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21, t022, t078, t091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94, t166, t728, t837, t1670, t2419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5306, t9886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cs typeface="Arial"/>
              </a:rPr>
              <a:t>t026, t227, t1991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43BC11F3-1A04-4AA5-90BD-CA433ABA1467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6667" r="-134" b="38547"/>
          <a:stretch/>
        </p:blipFill>
        <p:spPr>
          <a:xfrm>
            <a:off x="1469842" y="2139950"/>
            <a:ext cx="5926515" cy="2027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09604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384995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8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8, 190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12 patients were assigned to 29 spa-types and grouped into 2 CCs (with 8 spa-types). For 6 spa-types, no founder was determined, while 13 spa-types were singletons and 2 spa-types excluded by the  eBURP algorithm. The size of the circles represents the frequency of spa-types, the blue color marks the main founders, yellow the sub founders and black the descendants, respectively. </a:t>
            </a:r>
            <a:endParaRPr lang="de-DE" sz="1200" b="1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492990" cy="1754326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3, t005, t018, </a:t>
            </a:r>
            <a:r>
              <a:rPr lang="de-DE" sz="1200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024, t056, t078, t091, t122, t370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521, t1491, t4069, t5682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t605, t1050</a:t>
            </a: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6" name="Grafik 7">
            <a:extLst>
              <a:ext uri="{FF2B5EF4-FFF2-40B4-BE49-F238E27FC236}">
                <a16:creationId xmlns:a16="http://schemas.microsoft.com/office/drawing/2014/main" xmlns="" id="{F26291C0-845B-47F2-8649-00317D1AE90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537" t="19298" r="-671" b="10476"/>
          <a:stretch/>
        </p:blipFill>
        <p:spPr>
          <a:xfrm>
            <a:off x="1541279" y="1354137"/>
            <a:ext cx="5926516" cy="31783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678511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601880" y="4930122"/>
            <a:ext cx="5173733" cy="1200329"/>
          </a:xfrm>
          <a:prstGeom prst="rect">
            <a:avLst/>
          </a:prstGeom>
        </p:spPr>
        <p:txBody>
          <a:bodyPr wrap="square" anchor="t">
            <a:spAutoFit/>
          </a:bodyPr>
          <a:lstStyle/>
          <a:p>
            <a:pPr algn="just"/>
            <a:r>
              <a:rPr lang="de-DE" sz="1200" b="1">
                <a:latin typeface="Arial"/>
                <a:ea typeface="ＭＳ Ｐゴシック"/>
              </a:rPr>
              <a:t>Figure S9: </a:t>
            </a:r>
            <a:r>
              <a:rPr lang="de-DE" sz="1200">
                <a:latin typeface="Arial"/>
                <a:ea typeface="ＭＳ Ｐゴシック"/>
                <a:cs typeface="Arial"/>
              </a:rPr>
              <a:t>In center 9, 73 </a:t>
            </a:r>
            <a:r>
              <a:rPr lang="en-US" sz="1200" i="1">
                <a:latin typeface="Arial"/>
                <a:ea typeface="ＭＳ Ｐゴシック"/>
                <a:cs typeface="Arial"/>
              </a:rPr>
              <a:t>S. aureus</a:t>
            </a:r>
            <a:r>
              <a:rPr lang="en-US" sz="1200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>
                <a:latin typeface="Arial"/>
                <a:ea typeface="ＭＳ Ｐゴシック"/>
                <a:cs typeface="Arial"/>
              </a:rPr>
              <a:t>isolates from 4 patients were assigned to 14 spa-types. For 4 spa-types no founder CC was determined, while 10 spa-types were singletons. The size of the circles represents the frequency of spa-types, the blue color marks the main founders, yellow the sub founders and black the descendants, respectively. </a:t>
            </a:r>
            <a:endParaRPr lang="de-DE" sz="1200">
              <a:cs typeface="Arial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6028237" y="4930121"/>
            <a:ext cx="2649893" cy="1754326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r>
              <a:rPr lang="de-DE" sz="1200" b="1">
                <a:latin typeface="Arial"/>
                <a:ea typeface="ＭＳ Ｐゴシック"/>
              </a:rPr>
              <a:t>Singletons: </a:t>
            </a:r>
            <a:r>
              <a:rPr lang="de-DE" sz="1200">
                <a:latin typeface="Arial"/>
                <a:ea typeface="ＭＳ Ｐゴシック"/>
                <a:cs typeface="Arial"/>
              </a:rPr>
              <a:t>t005, t012, t056, t084, </a:t>
            </a: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>
                <a:latin typeface="Arial"/>
                <a:ea typeface="ＭＳ Ｐゴシック"/>
                <a:cs typeface="Arial"/>
              </a:rPr>
              <a:t>t116, t571, t688, t2419, t4570, t6372</a:t>
            </a:r>
            <a:r>
              <a:rPr lang="de-DE" sz="1200" b="1" dirty="0">
                <a:latin typeface="Arial"/>
                <a:ea typeface="ＭＳ Ｐゴシック"/>
              </a:rPr>
              <a:t/>
            </a:r>
            <a:br>
              <a:rPr lang="de-DE" sz="1200" b="1" dirty="0">
                <a:latin typeface="Arial"/>
                <a:ea typeface="ＭＳ Ｐゴシック"/>
              </a:rPr>
            </a:br>
            <a:endParaRPr lang="de-DE" sz="1200" b="1">
              <a:latin typeface="Arial"/>
              <a:ea typeface="ＭＳ Ｐゴシック"/>
              <a:cs typeface="Arial"/>
            </a:endParaRPr>
          </a:p>
          <a:p>
            <a:r>
              <a:rPr lang="de-DE" sz="1200" b="1" err="1">
                <a:latin typeface="Arial"/>
                <a:ea typeface="ＭＳ Ｐゴシック"/>
                <a:cs typeface="Arial"/>
              </a:rPr>
              <a:t>Excluded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> </a:t>
            </a:r>
            <a:r>
              <a:rPr lang="de-DE" sz="1200" b="1">
                <a:latin typeface="Arial"/>
                <a:ea typeface="ＭＳ Ｐゴシック"/>
                <a:cs typeface="Arial"/>
              </a:rPr>
              <a:t>spa-types: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>
                <a:latin typeface="Arial"/>
                <a:ea typeface="ＭＳ Ｐゴシック"/>
                <a:cs typeface="Arial"/>
              </a:rPr>
              <a:t>-</a:t>
            </a:r>
            <a:r>
              <a:rPr lang="de-DE" sz="1200" b="1" dirty="0">
                <a:latin typeface="Arial"/>
                <a:ea typeface="ＭＳ Ｐゴシック"/>
                <a:cs typeface="Arial"/>
              </a:rPr>
              <a:t/>
            </a:r>
            <a:br>
              <a:rPr lang="de-DE" sz="1200" b="1" dirty="0">
                <a:latin typeface="Arial"/>
                <a:ea typeface="ＭＳ Ｐゴシック"/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r>
              <a:rPr lang="de-DE" sz="1200" b="1" dirty="0">
                <a:cs typeface="Arial"/>
              </a:rPr>
              <a:t/>
            </a:r>
            <a:br>
              <a:rPr lang="de-DE" sz="1200" b="1" dirty="0">
                <a:cs typeface="Arial"/>
              </a:rPr>
            </a:br>
            <a:endParaRPr lang="de-DE" sz="1200">
              <a:cs typeface="Arial"/>
            </a:endParaRPr>
          </a:p>
        </p:txBody>
      </p:sp>
      <p:pic>
        <p:nvPicPr>
          <p:cNvPr id="7" name="Grafik 7">
            <a:extLst>
              <a:ext uri="{FF2B5EF4-FFF2-40B4-BE49-F238E27FC236}">
                <a16:creationId xmlns:a16="http://schemas.microsoft.com/office/drawing/2014/main" xmlns="" id="{4A03E5C0-A358-4129-BF9A-9C3EDAF1E02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t="14386" r="-134" b="49474"/>
          <a:stretch/>
        </p:blipFill>
        <p:spPr>
          <a:xfrm>
            <a:off x="1469842" y="2441575"/>
            <a:ext cx="5926515" cy="16357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1866980"/>
      </p:ext>
    </p:extLst>
  </p:cSld>
  <p:clrMapOvr>
    <a:masterClrMapping/>
  </p:clrMapOvr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tandarddesign.thmx</Template>
  <TotalTime>0</TotalTime>
  <Words>292</Words>
  <Application>Microsoft Macintosh PowerPoint</Application>
  <PresentationFormat>Bildschirmpräsentation (4:3)</PresentationFormat>
  <Paragraphs>78</Paragraphs>
  <Slides>17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7</vt:i4>
      </vt:variant>
    </vt:vector>
  </HeadingPairs>
  <TitlesOfParts>
    <vt:vector size="18" baseType="lpstr">
      <vt:lpstr>Standarddesig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Barbara Kahl</dc:creator>
  <cp:lastModifiedBy>Barbara Kahl</cp:lastModifiedBy>
  <cp:revision>466</cp:revision>
  <cp:lastPrinted>2019-04-30T09:40:59Z</cp:lastPrinted>
  <dcterms:created xsi:type="dcterms:W3CDTF">2019-04-22T20:08:00Z</dcterms:created>
  <dcterms:modified xsi:type="dcterms:W3CDTF">2019-05-30T11:33:48Z</dcterms:modified>
</cp:coreProperties>
</file>